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63" r:id="rId2"/>
  </p:sldIdLst>
  <p:sldSz cx="12192000" cy="6858000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995" autoAdjust="0"/>
    <p:restoredTop sz="94660"/>
  </p:normalViewPr>
  <p:slideViewPr>
    <p:cSldViewPr snapToGrid="0">
      <p:cViewPr varScale="1">
        <p:scale>
          <a:sx n="109" d="100"/>
          <a:sy n="109" d="100"/>
        </p:scale>
        <p:origin x="672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79B122F-F77A-444A-B520-4119BC3307A8}" type="datetimeFigureOut">
              <a:rPr lang="fr-FR" smtClean="0"/>
              <a:t>07/07/2025</a:t>
            </a:fld>
            <a:endParaRPr lang="fr-FR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fr-FR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B3B40A5-0611-402F-A8A3-ABBF1AEC1884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9201704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5FB1BA0-936A-DF02-ED08-50DAF1F3A14D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fr-FR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4E61DEC7-DE22-0423-3E27-4466F441FAA3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fr-FR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BB2C431-303A-D951-5673-4E8A2A77EC8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AE6AA2-F10F-4407-85E6-826C8739097B}" type="datetimeFigureOut">
              <a:rPr lang="fr-FR" smtClean="0"/>
              <a:t>07/07/2025</a:t>
            </a:fld>
            <a:endParaRPr lang="fr-FR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864C896-8502-3F36-C7C1-FC643B5A8B3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9DA1253-708A-4ED2-CE0D-64592CCA62A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3B530C-46B1-4131-90FD-AE33F734DDED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86397485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D4D61EF-01CB-E40E-4FB8-32D3417AD50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fr-FR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A8FC2575-CFDE-187E-444F-76CB15E05D3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fr-FR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EBD2737-ED31-434C-6256-21C5F36B859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AE6AA2-F10F-4407-85E6-826C8739097B}" type="datetimeFigureOut">
              <a:rPr lang="fr-FR" smtClean="0"/>
              <a:t>07/07/2025</a:t>
            </a:fld>
            <a:endParaRPr lang="fr-FR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D34EA6C-F631-482C-8347-0C4D3E4F549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2CE2A1A-B8FE-FB31-5953-64940424C48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3B530C-46B1-4131-90FD-AE33F734DDED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54403564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4C43B43F-DCD5-80F5-098D-2AD389959EF2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fr-FR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749260F0-E4F8-6B04-BFEC-32565F17282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fr-FR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14C6089-8041-E51A-AC66-D603E061701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AE6AA2-F10F-4407-85E6-826C8739097B}" type="datetimeFigureOut">
              <a:rPr lang="fr-FR" smtClean="0"/>
              <a:t>07/07/2025</a:t>
            </a:fld>
            <a:endParaRPr lang="fr-FR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C25958D-35BA-410C-496D-33A52094AA3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A8F7A2D-3432-2E4A-CF0A-7B1A5399F06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3B530C-46B1-4131-90FD-AE33F734DDED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81084208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32002E1-F760-9DC3-FBB0-2078A609635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fr-FR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17F2118-AD94-4BF6-2715-2B5D163693B8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fr-FR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9C7655C-567C-D7EC-086E-351DEE86C3C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AE6AA2-F10F-4407-85E6-826C8739097B}" type="datetimeFigureOut">
              <a:rPr lang="fr-FR" smtClean="0"/>
              <a:t>07/07/2025</a:t>
            </a:fld>
            <a:endParaRPr lang="fr-FR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369A1E9-BF2F-BF73-1B59-5DD440A7BB0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EE55E37-AE81-678A-D750-08BF00EC169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3B530C-46B1-4131-90FD-AE33F734DDED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47834182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7E8C769-18E8-62B9-A159-6570E8A78C2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fr-FR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5E66848-19EE-C14A-AB97-1294806CB2A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43671CB-16C5-7ABF-C5DD-CD9616574F0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AE6AA2-F10F-4407-85E6-826C8739097B}" type="datetimeFigureOut">
              <a:rPr lang="fr-FR" smtClean="0"/>
              <a:t>07/07/2025</a:t>
            </a:fld>
            <a:endParaRPr lang="fr-FR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194E9F3-5405-2B15-5BC4-245CAB15A41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E929467-33CC-3224-A00B-33A0BCD30B0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3B530C-46B1-4131-90FD-AE33F734DDED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04792889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D2877E1-B9F2-9FA1-485D-BFAD04C28A8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fr-FR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09A4B8F-0896-FB51-AC0E-8B230764CEE2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fr-FR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6FA6C18F-1DED-4CDF-8409-88C737AE6C8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fr-FR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803DC38-2328-012C-A046-AC2C775A71B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AE6AA2-F10F-4407-85E6-826C8739097B}" type="datetimeFigureOut">
              <a:rPr lang="fr-FR" smtClean="0"/>
              <a:t>07/07/2025</a:t>
            </a:fld>
            <a:endParaRPr lang="fr-FR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8D0BA32E-4C84-B011-A24B-026F7013290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203EC52-705C-91CE-4391-C5D471C31BF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3B530C-46B1-4131-90FD-AE33F734DDED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92348865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EE15206-4239-DBAB-F5CD-9FE1A77B03A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fr-FR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F0B1A4B-C7E9-30E3-F1F9-7190D20CE08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A6EA6A51-D19C-2528-07EE-F21394A3AC8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fr-FR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B551918B-F1A6-FAB1-0C64-EC5CF9DFAD21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B37E2159-E434-D6E5-7BAB-3029C9184769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fr-FR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058875EC-6582-5693-F31A-04E3D77D837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AE6AA2-F10F-4407-85E6-826C8739097B}" type="datetimeFigureOut">
              <a:rPr lang="fr-FR" smtClean="0"/>
              <a:t>07/07/2025</a:t>
            </a:fld>
            <a:endParaRPr lang="fr-FR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5A4CDC8F-B3D4-901F-393E-C1D7F5F7B69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73E68615-D49E-20FE-A917-8FB85435216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3B530C-46B1-4131-90FD-AE33F734DDED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29561400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5E86584-CE89-2BE6-2FE8-4A2B32F3F49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fr-FR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51E29BE8-A7C3-1801-D71F-71AA04DDC86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AE6AA2-F10F-4407-85E6-826C8739097B}" type="datetimeFigureOut">
              <a:rPr lang="fr-FR" smtClean="0"/>
              <a:t>07/07/2025</a:t>
            </a:fld>
            <a:endParaRPr lang="fr-FR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95ADA298-D4A5-1A25-57F1-D4DA76F22FF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E60F087E-FCAB-34C4-795C-D1ED88E0BD0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3B530C-46B1-4131-90FD-AE33F734DDED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51090833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28E4BDE2-2B73-0EEE-4885-AB856804BDC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AE6AA2-F10F-4407-85E6-826C8739097B}" type="datetimeFigureOut">
              <a:rPr lang="fr-FR" smtClean="0"/>
              <a:t>07/07/2025</a:t>
            </a:fld>
            <a:endParaRPr lang="fr-FR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A350EF5B-4421-B9A8-3954-9500615ACBF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5EB05F5B-83F8-8E3E-4AA8-20EC1D2EEA8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3B530C-46B1-4131-90FD-AE33F734DDED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76620441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E50ACA7-4D9D-3129-ABE1-A83A69A8B4B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fr-FR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DE01D95-DA54-5666-5F6B-FD4C3439B0FC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fr-FR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E0ECDC43-3F26-D95E-3BF8-E9107EE6C6C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0378AEF-FAAB-5F8C-A401-2EF4E418221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AE6AA2-F10F-4407-85E6-826C8739097B}" type="datetimeFigureOut">
              <a:rPr lang="fr-FR" smtClean="0"/>
              <a:t>07/07/2025</a:t>
            </a:fld>
            <a:endParaRPr lang="fr-FR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DAFF32B-9C64-8049-5989-2678315F840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3CAF706-2F13-B1FC-B7C7-5A535361BD5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3B530C-46B1-4131-90FD-AE33F734DDED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34077494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503313D-A655-A393-8D90-F1E021DF3FC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fr-FR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8E99063B-D626-CEDB-291E-F2B02206BD01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07427751-3844-9BBA-4566-39F16D060EF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7416AA6-9F47-BE2E-E868-48F112A43C5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AE6AA2-F10F-4407-85E6-826C8739097B}" type="datetimeFigureOut">
              <a:rPr lang="fr-FR" smtClean="0"/>
              <a:t>07/07/2025</a:t>
            </a:fld>
            <a:endParaRPr lang="fr-FR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6B18507-B2E6-4780-4507-164BA30AE2F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B9EA6BC-FDBA-EC1F-232A-DBCDE8387C8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3B530C-46B1-4131-90FD-AE33F734DDED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66980680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A7CBF482-DEE0-E62B-4637-D8CA4364C80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fr-FR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34F2807-0383-6AF7-D086-B342381ECA1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fr-FR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18DE6EE-3E6B-E29C-9EA5-A4911B5DF86A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52AE6AA2-F10F-4407-85E6-826C8739097B}" type="datetimeFigureOut">
              <a:rPr lang="fr-FR" smtClean="0"/>
              <a:t>07/07/2025</a:t>
            </a:fld>
            <a:endParaRPr lang="fr-FR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E012443-6AB0-6F50-F681-E61A77CB3586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90A0C8E-71B4-3163-A0A4-7FB27D9A7F28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973B530C-46B1-4131-90FD-AE33F734DDED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53727219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9653764F-5D16-5079-E043-8F9F7A03AFB1}"/>
              </a:ext>
            </a:extLst>
          </p:cNvPr>
          <p:cNvSpPr txBox="1"/>
          <p:nvPr/>
        </p:nvSpPr>
        <p:spPr>
          <a:xfrm>
            <a:off x="103799" y="5695367"/>
            <a:ext cx="11984402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1400" b="1" dirty="0"/>
              <a:t>Supplementary Figure S2. </a:t>
            </a:r>
            <a:r>
              <a:rPr lang="en-GB" sz="1400" dirty="0"/>
              <a:t>Beta diversity analysis using Principal Coordinates Analysis (</a:t>
            </a:r>
            <a:r>
              <a:rPr lang="en-GB" sz="1400" dirty="0" err="1"/>
              <a:t>PCoA</a:t>
            </a:r>
            <a:r>
              <a:rPr lang="en-GB" sz="1400" dirty="0"/>
              <a:t>) based on Bray-Curtis dissimilarity at baseline, 3 months, and 12 months. Treatment outcomes are represented by </a:t>
            </a:r>
            <a:r>
              <a:rPr lang="en-GB" sz="1400" dirty="0" err="1"/>
              <a:t>colored</a:t>
            </a:r>
            <a:r>
              <a:rPr lang="en-GB" sz="1400" dirty="0"/>
              <a:t> dots (red: failure, green: success, </a:t>
            </a:r>
            <a:r>
              <a:rPr lang="en-GB" sz="1400" dirty="0" err="1"/>
              <a:t>gray</a:t>
            </a:r>
            <a:r>
              <a:rPr lang="en-GB" sz="1400" dirty="0"/>
              <a:t>: unknown). No significant differences in beta diversity were found between success and failure groups (PERMANOVA, R² = 0.0227, P &gt; 0.05).</a:t>
            </a:r>
            <a:endParaRPr lang="fr-FR" sz="1400" dirty="0"/>
          </a:p>
        </p:txBody>
      </p:sp>
      <p:pic>
        <p:nvPicPr>
          <p:cNvPr id="6" name="Picture 5" descr="A graph of a number of months&#10;&#10;AI-generated content may be incorrect.">
            <a:extLst>
              <a:ext uri="{FF2B5EF4-FFF2-40B4-BE49-F238E27FC236}">
                <a16:creationId xmlns:a16="http://schemas.microsoft.com/office/drawing/2014/main" id="{2C1F1281-6366-E9D4-3707-776EB7ADCDCC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196651" y="723286"/>
            <a:ext cx="8103034" cy="431887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04665194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35</TotalTime>
  <Words>72</Words>
  <Application>Microsoft Office PowerPoint</Application>
  <PresentationFormat>Widescreen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ptos</vt:lpstr>
      <vt:lpstr>Aptos Display</vt:lpstr>
      <vt:lpstr>Arial</vt:lpstr>
      <vt:lpstr>Office Theme</vt:lpstr>
      <vt:lpstr>PowerPoint Presentation</vt:lpstr>
    </vt:vector>
  </TitlesOfParts>
  <Company>IARC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Tarik Gheit</dc:creator>
  <cp:lastModifiedBy>Arun Sharma</cp:lastModifiedBy>
  <cp:revision>23</cp:revision>
  <dcterms:created xsi:type="dcterms:W3CDTF">2025-02-21T17:56:07Z</dcterms:created>
  <dcterms:modified xsi:type="dcterms:W3CDTF">2025-07-07T08:09:54Z</dcterms:modified>
</cp:coreProperties>
</file>